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3" d="100"/>
          <a:sy n="83" d="100"/>
        </p:scale>
        <p:origin x="-124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091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418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592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406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226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055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267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305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151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744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87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95FC9-321A-1748-96AA-DD01CFD68407}" type="datetimeFigureOut">
              <a:rPr lang="en-US" smtClean="0"/>
              <a:t>12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3346A-A4C2-8F47-9DF1-7706442041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475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23" name="Group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9690348"/>
              </p:ext>
            </p:extLst>
          </p:nvPr>
        </p:nvGraphicFramePr>
        <p:xfrm>
          <a:off x="2286003" y="990601"/>
          <a:ext cx="3987229" cy="5434434"/>
        </p:xfrm>
        <a:graphic>
          <a:graphicData uri="http://schemas.openxmlformats.org/drawingml/2006/table">
            <a:tbl>
              <a:tblPr/>
              <a:tblGrid>
                <a:gridCol w="1112334"/>
                <a:gridCol w="1482543"/>
                <a:gridCol w="1392352"/>
              </a:tblGrid>
              <a:tr h="187322">
                <a:tc gridSpan="3"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Breakage Sites in WWOX </a:t>
                      </a:r>
                      <a:r>
                        <a:rPr kumimoji="0" lang="en-US" sz="9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sufficient and deficient MEFs after </a:t>
                      </a:r>
                      <a:r>
                        <a:rPr kumimoji="0" lang="en-US" sz="900" b="1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Aphidicolin</a:t>
                      </a: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 </a:t>
                      </a:r>
                      <a:r>
                        <a:rPr kumimoji="0" lang="en-US" sz="9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(0.2 </a:t>
                      </a:r>
                      <a:r>
                        <a:rPr kumimoji="0" lang="en-US" sz="9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charset="0"/>
                          <a:ea typeface="ＭＳ Ｐゴシック" charset="0"/>
                          <a:cs typeface="Arial" charset="0"/>
                        </a:rPr>
                        <a:t>m</a:t>
                      </a:r>
                      <a:r>
                        <a:rPr kumimoji="0" lang="en-US" sz="9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M</a:t>
                      </a:r>
                      <a:r>
                        <a:rPr kumimoji="0" lang="en-US" sz="9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) Treatment</a:t>
                      </a:r>
                      <a:endParaRPr kumimoji="0" lang="en-US" sz="9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6075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Chromosome </a:t>
                      </a: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Band       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FF33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Chromosome 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33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WWOX </a:t>
                      </a:r>
                      <a:r>
                        <a:rPr kumimoji="0" 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FF33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#3-WT 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33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WWOX </a:t>
                      </a:r>
                      <a:r>
                        <a:rPr kumimoji="0" lang="en-US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FF33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#5-KO  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571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B,1C2,1F,1H5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B,2H3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3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3Bx2,3F3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3A2x2,3F1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571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4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4C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4Bx3,4C4,4C6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5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5Bx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5Bx3,5F,5G3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6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6C1,6C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6B3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7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7F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7B3,7B5,7D,7D1,7F1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571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8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8A1,8A4,8C3,8D,8E1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9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9D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0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0B4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0C1x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571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1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2A1x2,12B,12C1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3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4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4E4,14A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4E2x3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571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5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5B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6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6B1,16C1x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7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7E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7E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571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8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8C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9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9D1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7322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X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9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XA2,XB,XF3x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5571"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# cells analyzed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3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2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70506">
                <a:tc gridSpan="3">
                  <a:txBody>
                    <a:bodyPr/>
                    <a:lstStyle/>
                    <a:p>
                      <a:pPr marL="0" marR="0" lvl="0" indent="0" algn="l" defTabSz="457200" rtl="1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Lower case x = times, e.g. under </a:t>
                      </a:r>
                      <a:r>
                        <a:rPr kumimoji="0" lang="en-US" sz="9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WWOX </a:t>
                      </a:r>
                      <a:r>
                        <a:rPr kumimoji="0" lang="en-US" sz="9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#5, chromosome band 5B has 3 breaks: 5Bx3 in table. This is either a break in 5B in three different cells, or one cell had 2 breaks (both chromosomes 5) and another cell had 1 break in that band. </a:t>
                      </a:r>
                    </a:p>
                  </a:txBody>
                  <a:tcPr marL="10084" marR="10084" marT="10084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4452" name="Text Box 118"/>
          <p:cNvSpPr txBox="1">
            <a:spLocks noChangeArrowheads="1"/>
          </p:cNvSpPr>
          <p:nvPr/>
        </p:nvSpPr>
        <p:spPr bwMode="auto">
          <a:xfrm>
            <a:off x="800100" y="263478"/>
            <a:ext cx="109571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l" rtl="0" eaLnBrk="1" hangingPunct="1"/>
            <a:r>
              <a:rPr lang="en-US" sz="1800" dirty="0"/>
              <a:t>Table-</a:t>
            </a:r>
            <a:r>
              <a:rPr lang="en-US" sz="1800" dirty="0" smtClean="0"/>
              <a:t>1S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191616933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57</Words>
  <Application>Microsoft Macintosh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brew university of jerusale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2S. Breakage sites in Wwox-MEFs following treatment with Aphidicolin</dc:title>
  <dc:creator>mohammad abu odeh</dc:creator>
  <cp:lastModifiedBy>Rami Aqeilan</cp:lastModifiedBy>
  <cp:revision>5</cp:revision>
  <dcterms:created xsi:type="dcterms:W3CDTF">2015-12-01T10:14:25Z</dcterms:created>
  <dcterms:modified xsi:type="dcterms:W3CDTF">2015-12-10T14:27:48Z</dcterms:modified>
</cp:coreProperties>
</file>